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1263" r:id="rId2"/>
    <p:sldId id="1266" r:id="rId3"/>
    <p:sldId id="1262" r:id="rId4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940"/>
    <p:restoredTop sz="96405"/>
  </p:normalViewPr>
  <p:slideViewPr>
    <p:cSldViewPr snapToGrid="0">
      <p:cViewPr varScale="1">
        <p:scale>
          <a:sx n="121" d="100"/>
          <a:sy n="121" d="100"/>
        </p:scale>
        <p:origin x="773" y="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AF273FD-D776-C94F-8B14-EEC6C252AC3A}" type="datetimeFigureOut">
              <a:rPr kumimoji="1" lang="ja-JP" altLang="en-US" smtClean="0"/>
              <a:t>2025/11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48EF82-D3C0-884D-A6D9-FA59E73E2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26409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Figure 3. </a:t>
            </a:r>
            <a:r>
              <a:rPr lang="en-US" altLang="ja-JP" sz="1800" b="1" kern="100" dirty="0">
                <a:effectLst/>
                <a:latin typeface="Times New Roman" panose="02020603050405020304" pitchFamily="18" charset="0"/>
                <a:ea typeface="游ゴシック Light" panose="020B0300000000000000" pitchFamily="34" charset="-128"/>
                <a:cs typeface="Times New Roman" panose="02020603050405020304" pitchFamily="18" charset="0"/>
              </a:rPr>
              <a:t>Genetic correlations across different diseases and traits</a:t>
            </a:r>
            <a:endParaRPr lang="ja-JP" altLang="ja-JP" sz="1800" b="1" kern="100">
              <a:effectLst/>
              <a:latin typeface="游ゴシック Light" panose="020B0300000000000000" pitchFamily="34" charset="-128"/>
              <a:ea typeface="游ゴシック Light" panose="020B0300000000000000" pitchFamily="34" charset="-128"/>
              <a:cs typeface="Times New Roman" panose="02020603050405020304" pitchFamily="18" charset="0"/>
            </a:endParaRPr>
          </a:p>
          <a:p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.</a:t>
            </a:r>
          </a:p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10BF37A-CD60-7D43-B7D4-4C96CBED869F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163251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Figure 3. </a:t>
            </a:r>
            <a:r>
              <a:rPr lang="en-US" altLang="ja-JP" sz="1800" b="1" kern="100" dirty="0">
                <a:effectLst/>
                <a:latin typeface="Times New Roman" panose="02020603050405020304" pitchFamily="18" charset="0"/>
                <a:ea typeface="游ゴシック Light" panose="020B0300000000000000" pitchFamily="34" charset="-128"/>
                <a:cs typeface="Times New Roman" panose="02020603050405020304" pitchFamily="18" charset="0"/>
              </a:rPr>
              <a:t>Genetic correlations across different diseases and traits</a:t>
            </a:r>
            <a:endParaRPr lang="ja-JP" altLang="ja-JP" sz="1800" b="1" kern="100">
              <a:effectLst/>
              <a:latin typeface="游ゴシック Light" panose="020B0300000000000000" pitchFamily="34" charset="-128"/>
              <a:ea typeface="游ゴシック Light" panose="020B0300000000000000" pitchFamily="34" charset="-128"/>
              <a:cs typeface="Times New Roman" panose="02020603050405020304" pitchFamily="18" charset="0"/>
            </a:endParaRPr>
          </a:p>
          <a:p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.</a:t>
            </a:r>
          </a:p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10BF37A-CD60-7D43-B7D4-4C96CBED869F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80586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2897779-1565-3624-68CE-65F60C66B49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15F8250C-FA36-BDE1-1AA5-A7E1EC15A76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00F4DB3-A424-BDD8-0C11-19F7F1F45B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3FFFE-C12F-F749-9395-4BC06AA8D844}" type="datetimeFigureOut">
              <a:rPr kumimoji="1" lang="ja-JP" altLang="en-US" smtClean="0"/>
              <a:t>2025/11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DB36A6C-5454-AF65-9502-A78B4255BE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7AE90FB-AEEE-F70E-BC38-AD753F5000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CF061-BCAD-E249-9608-A93EB92C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30362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A369FC4-4676-EEE2-67A3-B57BCD5172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C995FDE-97CC-DB0F-4403-63120D509A0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3114FEE-F233-C068-D416-0485A65FE5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3FFFE-C12F-F749-9395-4BC06AA8D844}" type="datetimeFigureOut">
              <a:rPr kumimoji="1" lang="ja-JP" altLang="en-US" smtClean="0"/>
              <a:t>2025/11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FD81610-819E-E4B0-A1DC-1647E6D700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98BA390-917D-9141-9D27-2704993135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CF061-BCAD-E249-9608-A93EB92C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19370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47560B20-43D1-7620-CD30-A1035201BE3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9958B87-3B48-8E62-09F4-75A52976C6E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F993247-B6DA-9564-1688-22AFC141E2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3FFFE-C12F-F749-9395-4BC06AA8D844}" type="datetimeFigureOut">
              <a:rPr kumimoji="1" lang="ja-JP" altLang="en-US" smtClean="0"/>
              <a:t>2025/11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4F92AF3-2B89-F61F-2866-EDD01483BC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A71EF29-D702-ABDC-AEB6-A68E194F9C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CF061-BCAD-E249-9608-A93EB92C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23451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B7FF29E-7694-9A06-E4C0-239D528933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6C54A05-9525-F5E6-10B2-81288D4E3B6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6A410F1-62B3-785F-D704-D9D1972763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3FFFE-C12F-F749-9395-4BC06AA8D844}" type="datetimeFigureOut">
              <a:rPr kumimoji="1" lang="ja-JP" altLang="en-US" smtClean="0"/>
              <a:t>2025/11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B304023-7F54-6A66-0895-8E10AAD121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2BD9E95-1228-C064-6E99-CA0FB797E6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CF061-BCAD-E249-9608-A93EB92C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89520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342B7B1-3616-9232-BBE4-943FDC8103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54C5B5F-9966-04DA-4826-6ED72C23D2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9FF06E8-193E-66E4-4A12-11C7801E58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3FFFE-C12F-F749-9395-4BC06AA8D844}" type="datetimeFigureOut">
              <a:rPr kumimoji="1" lang="ja-JP" altLang="en-US" smtClean="0"/>
              <a:t>2025/11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2331096-893C-78FC-2621-0890DD283B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C46B6F9-1EBF-C38F-3FB7-F30B57D697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CF061-BCAD-E249-9608-A93EB92C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37997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0F16247-3D91-11CE-A780-BFC944C75B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4D696F5-CFFA-C40E-3A4F-291E881C74E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1F50891-4781-2F63-BEBE-426D1F58793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B3C1487-551A-764D-D90A-19C2FCFF32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3FFFE-C12F-F749-9395-4BC06AA8D844}" type="datetimeFigureOut">
              <a:rPr kumimoji="1" lang="ja-JP" altLang="en-US" smtClean="0"/>
              <a:t>2025/11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623140C-7F30-72F0-F3B8-D92FF04321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D959028-DA36-4C22-BD5A-679CE615E0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CF061-BCAD-E249-9608-A93EB92C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41527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7C66278-6733-456F-1260-A418783879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09B2F02-7028-F051-BD38-20E4E90C53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8B10DD6-DBDA-6DE3-CB54-FD2DAC9F813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58810D2D-ECDF-F60E-35B7-58400706F0D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C6EBB337-15DE-1896-6D58-A46E7A44427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2758358A-6FF1-2EC6-F7DD-249707CE51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3FFFE-C12F-F749-9395-4BC06AA8D844}" type="datetimeFigureOut">
              <a:rPr kumimoji="1" lang="ja-JP" altLang="en-US" smtClean="0"/>
              <a:t>2025/11/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42480468-E6EC-370C-073C-6436FB7722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A6D6E5BF-0F32-2417-F95F-367286BC23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CF061-BCAD-E249-9608-A93EB92C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86776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8CCD76D-A441-C3BB-9F60-FC0B1F30BB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2C7EF543-83A9-D733-F6DC-C0EB0EECE1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3FFFE-C12F-F749-9395-4BC06AA8D844}" type="datetimeFigureOut">
              <a:rPr kumimoji="1" lang="ja-JP" altLang="en-US" smtClean="0"/>
              <a:t>2025/11/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3D0DEB8-3B93-0C06-FF57-B851B619F8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54DF3DF9-9100-D2BE-2C18-95C7F56F9C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CF061-BCAD-E249-9608-A93EB92C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28713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C6ADD7C8-9D7A-66E8-D08F-D73674D1BA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3FFFE-C12F-F749-9395-4BC06AA8D844}" type="datetimeFigureOut">
              <a:rPr kumimoji="1" lang="ja-JP" altLang="en-US" smtClean="0"/>
              <a:t>2025/11/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F2665AAA-0DB1-013B-006D-46A587532E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B2D8AF49-3EAC-8907-CE2A-E685500BB5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CF061-BCAD-E249-9608-A93EB92C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47084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3EDCE17-9B4D-5C0B-D703-DC78B79387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844A31B-C66B-E6ED-F982-7C08A2DD0F3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135A968-BB75-CE24-0D09-980021AA83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049E450-D94C-ED14-CA5B-74D14DE154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3FFFE-C12F-F749-9395-4BC06AA8D844}" type="datetimeFigureOut">
              <a:rPr kumimoji="1" lang="ja-JP" altLang="en-US" smtClean="0"/>
              <a:t>2025/11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BABA780-46DA-FD2B-0F04-57A5998984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DC45CF9-0C5E-EF44-C09A-3F90E87150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CF061-BCAD-E249-9608-A93EB92C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22336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5A04A35-D1B7-2A3C-9058-6CD89F49C7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20891C48-9959-D335-73EF-F6AC3357AB5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879689F-FF0B-0548-5C9A-1DCF78FA455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A8E4F1A-556B-ED24-9BAC-5C4270F861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3FFFE-C12F-F749-9395-4BC06AA8D844}" type="datetimeFigureOut">
              <a:rPr kumimoji="1" lang="ja-JP" altLang="en-US" smtClean="0"/>
              <a:t>2025/11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1F16C91-A859-1E92-67EB-79AB04037A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52BE164-DD7B-0A7A-AD25-135D1A78DB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BCF061-BCAD-E249-9608-A93EB92C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917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7D8A7665-5118-33A9-0CB1-A9D0D5B813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43AE49F-ECEF-30C9-6EAC-DB80B94958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FDD5236-49B3-A1BE-7B3D-B5449506AFC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53FFFE-C12F-F749-9395-4BC06AA8D844}" type="datetimeFigureOut">
              <a:rPr kumimoji="1" lang="ja-JP" altLang="en-US" smtClean="0"/>
              <a:t>2025/11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076624C-FD44-8947-8C2D-3BE73ECEDF0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B075A8D-168E-26A7-DD4A-124E5C52D55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BCF061-BCAD-E249-9608-A93EB92C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59987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12" Type="http://schemas.openxmlformats.org/officeDocument/2006/relationships/image" Target="../media/image11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g"/><Relationship Id="rId11" Type="http://schemas.openxmlformats.org/officeDocument/2006/relationships/image" Target="../media/image10.jpg"/><Relationship Id="rId5" Type="http://schemas.openxmlformats.org/officeDocument/2006/relationships/image" Target="../media/image4.jpg"/><Relationship Id="rId10" Type="http://schemas.openxmlformats.org/officeDocument/2006/relationships/image" Target="../media/image9.jpg"/><Relationship Id="rId4" Type="http://schemas.openxmlformats.org/officeDocument/2006/relationships/image" Target="../media/image3.jpg"/><Relationship Id="rId9" Type="http://schemas.openxmlformats.org/officeDocument/2006/relationships/image" Target="../media/image8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jpg"/><Relationship Id="rId3" Type="http://schemas.openxmlformats.org/officeDocument/2006/relationships/image" Target="../media/image13.jpg"/><Relationship Id="rId7" Type="http://schemas.openxmlformats.org/officeDocument/2006/relationships/image" Target="../media/image17.jpg"/><Relationship Id="rId12" Type="http://schemas.openxmlformats.org/officeDocument/2006/relationships/image" Target="../media/image22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jpg"/><Relationship Id="rId11" Type="http://schemas.openxmlformats.org/officeDocument/2006/relationships/image" Target="../media/image21.jpg"/><Relationship Id="rId5" Type="http://schemas.openxmlformats.org/officeDocument/2006/relationships/image" Target="../media/image15.jpg"/><Relationship Id="rId10" Type="http://schemas.openxmlformats.org/officeDocument/2006/relationships/image" Target="../media/image20.jpg"/><Relationship Id="rId4" Type="http://schemas.openxmlformats.org/officeDocument/2006/relationships/image" Target="../media/image14.jpg"/><Relationship Id="rId9" Type="http://schemas.openxmlformats.org/officeDocument/2006/relationships/image" Target="../media/image19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1F3620D-8ECE-CBC3-65D9-B145EA3F4315}"/>
              </a:ext>
            </a:extLst>
          </p:cNvPr>
          <p:cNvSpPr txBox="1"/>
          <p:nvPr/>
        </p:nvSpPr>
        <p:spPr>
          <a:xfrm>
            <a:off x="-107006" y="49558"/>
            <a:ext cx="1241461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Fig. S1. Regional association plots for the </a:t>
            </a:r>
            <a:r>
              <a:rPr lang="en-US" altLang="ja-JP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</a:t>
            </a:r>
            <a:r>
              <a:rPr lang="en-US" altLang="ja-JP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ndidate susceptibility loci </a:t>
            </a:r>
          </a:p>
          <a:p>
            <a:pPr algn="ctr"/>
            <a:r>
              <a:rPr lang="en-US" altLang="ja-JP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in </a:t>
            </a:r>
            <a:r>
              <a:rPr lang="en-US" altLang="ja-JP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G</a:t>
            </a:r>
            <a:r>
              <a:rPr lang="en-US" altLang="ja-JP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-GWAS</a:t>
            </a:r>
            <a:r>
              <a:rPr lang="en-US" altLang="ja-JP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nd TWAS</a:t>
            </a:r>
            <a:endParaRPr lang="ja-JP" altLang="ja-JP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6984646C-3C8C-AB95-95AC-348457D5819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5818" y="880563"/>
            <a:ext cx="2057140" cy="1440000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13A913A0-73D0-109C-C6B5-021DD22F11C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22300" y="880563"/>
            <a:ext cx="2057140" cy="1440000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ECBE085C-5BC5-EDAA-53A2-0C58E507B75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98782" y="880563"/>
            <a:ext cx="2057140" cy="1440000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27AA7452-C6B4-D395-36BD-AE7832C0D6B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675259" y="880563"/>
            <a:ext cx="2057140" cy="1440000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04C3DE0C-65E6-CA30-D7A6-E202E751E9C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051747" y="880563"/>
            <a:ext cx="2057140" cy="1440000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6787B668-914F-3FC6-C29A-4974FC155902}"/>
              </a:ext>
            </a:extLst>
          </p:cNvPr>
          <p:cNvSpPr txBox="1"/>
          <p:nvPr/>
        </p:nvSpPr>
        <p:spPr>
          <a:xfrm>
            <a:off x="308518" y="740468"/>
            <a:ext cx="2770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FD25CC11-1DCB-61C6-A923-F293E39BE4C0}"/>
              </a:ext>
            </a:extLst>
          </p:cNvPr>
          <p:cNvSpPr txBox="1"/>
          <p:nvPr/>
        </p:nvSpPr>
        <p:spPr>
          <a:xfrm>
            <a:off x="2686317" y="740468"/>
            <a:ext cx="2770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60D7E4C3-9CD1-892C-9F05-B59EDEF15EF7}"/>
              </a:ext>
            </a:extLst>
          </p:cNvPr>
          <p:cNvSpPr txBox="1"/>
          <p:nvPr/>
        </p:nvSpPr>
        <p:spPr>
          <a:xfrm>
            <a:off x="5064115" y="740468"/>
            <a:ext cx="2770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ED712BA7-77F8-3BDA-ABDF-2EFF2055C547}"/>
              </a:ext>
            </a:extLst>
          </p:cNvPr>
          <p:cNvSpPr txBox="1"/>
          <p:nvPr/>
        </p:nvSpPr>
        <p:spPr>
          <a:xfrm>
            <a:off x="7441913" y="740468"/>
            <a:ext cx="2770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EE4DC45E-B0F2-6A60-F0BC-1E81F41F07A3}"/>
              </a:ext>
            </a:extLst>
          </p:cNvPr>
          <p:cNvSpPr txBox="1"/>
          <p:nvPr/>
        </p:nvSpPr>
        <p:spPr>
          <a:xfrm>
            <a:off x="9819712" y="740468"/>
            <a:ext cx="2770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8BA03900-CD8A-3FB6-E58B-BA7561C65C60}"/>
              </a:ext>
            </a:extLst>
          </p:cNvPr>
          <p:cNvSpPr txBox="1"/>
          <p:nvPr/>
        </p:nvSpPr>
        <p:spPr>
          <a:xfrm rot="16200000">
            <a:off x="218545" y="1433916"/>
            <a:ext cx="646432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AA539307-1D85-C4AC-9EA8-818F3494E858}"/>
              </a:ext>
            </a:extLst>
          </p:cNvPr>
          <p:cNvSpPr txBox="1"/>
          <p:nvPr/>
        </p:nvSpPr>
        <p:spPr>
          <a:xfrm rot="16200000">
            <a:off x="2615830" y="1404526"/>
            <a:ext cx="646432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F0B6951A-56C3-6050-DCF7-827C04F43097}"/>
              </a:ext>
            </a:extLst>
          </p:cNvPr>
          <p:cNvSpPr txBox="1"/>
          <p:nvPr/>
        </p:nvSpPr>
        <p:spPr>
          <a:xfrm rot="16200000">
            <a:off x="7334043" y="1430051"/>
            <a:ext cx="646432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48735504-1C4E-D680-CC75-E1BD8F5C5BCF}"/>
              </a:ext>
            </a:extLst>
          </p:cNvPr>
          <p:cNvSpPr txBox="1"/>
          <p:nvPr/>
        </p:nvSpPr>
        <p:spPr>
          <a:xfrm rot="16200000">
            <a:off x="4960686" y="1445169"/>
            <a:ext cx="646432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0E8B261C-8F5F-E142-EBF0-58E7A714A054}"/>
              </a:ext>
            </a:extLst>
          </p:cNvPr>
          <p:cNvSpPr txBox="1"/>
          <p:nvPr/>
        </p:nvSpPr>
        <p:spPr>
          <a:xfrm rot="16200000">
            <a:off x="9728527" y="1366828"/>
            <a:ext cx="646432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8B334809-9515-753A-897B-8004D4D609FB}"/>
              </a:ext>
            </a:extLst>
          </p:cNvPr>
          <p:cNvSpPr txBox="1"/>
          <p:nvPr/>
        </p:nvSpPr>
        <p:spPr>
          <a:xfrm>
            <a:off x="875318" y="2236900"/>
            <a:ext cx="1398140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osition on chr2 (Mb)</a:t>
            </a: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94BEF97F-01EE-01EB-CACC-3E682350DE11}"/>
              </a:ext>
            </a:extLst>
          </p:cNvPr>
          <p:cNvSpPr txBox="1"/>
          <p:nvPr/>
        </p:nvSpPr>
        <p:spPr>
          <a:xfrm>
            <a:off x="3234582" y="2236900"/>
            <a:ext cx="1398140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osition on chr3 (Mb)</a:t>
            </a: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33B95A71-A54B-B23B-1751-9560ECD8C072}"/>
              </a:ext>
            </a:extLst>
          </p:cNvPr>
          <p:cNvSpPr txBox="1"/>
          <p:nvPr/>
        </p:nvSpPr>
        <p:spPr>
          <a:xfrm>
            <a:off x="5593846" y="2236900"/>
            <a:ext cx="1398140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osition on chr4 (Mb)</a:t>
            </a: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FAEB794E-7098-BA63-83CC-5765A93438A8}"/>
              </a:ext>
            </a:extLst>
          </p:cNvPr>
          <p:cNvSpPr txBox="1"/>
          <p:nvPr/>
        </p:nvSpPr>
        <p:spPr>
          <a:xfrm>
            <a:off x="7953110" y="2236900"/>
            <a:ext cx="1398140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osition on chr4 (Mb)</a:t>
            </a: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16FDC543-C07B-BFB1-99D4-C2F76469264F}"/>
              </a:ext>
            </a:extLst>
          </p:cNvPr>
          <p:cNvSpPr txBox="1"/>
          <p:nvPr/>
        </p:nvSpPr>
        <p:spPr>
          <a:xfrm>
            <a:off x="10312373" y="2236900"/>
            <a:ext cx="1531514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osition on chr7(Mb)</a:t>
            </a: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8DDBAF7B-A404-371E-43A4-F03AB122B016}"/>
              </a:ext>
            </a:extLst>
          </p:cNvPr>
          <p:cNvSpPr txBox="1"/>
          <p:nvPr/>
        </p:nvSpPr>
        <p:spPr>
          <a:xfrm>
            <a:off x="1127104" y="1050388"/>
            <a:ext cx="865943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rs187486988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7752510C-0965-26BB-D095-9A6B275262E5}"/>
              </a:ext>
            </a:extLst>
          </p:cNvPr>
          <p:cNvSpPr txBox="1"/>
          <p:nvPr/>
        </p:nvSpPr>
        <p:spPr>
          <a:xfrm>
            <a:off x="3542425" y="1070035"/>
            <a:ext cx="801823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rs79794400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EC3A02B2-903D-EF99-1401-B1E01E7C71DF}"/>
              </a:ext>
            </a:extLst>
          </p:cNvPr>
          <p:cNvSpPr txBox="1"/>
          <p:nvPr/>
        </p:nvSpPr>
        <p:spPr>
          <a:xfrm>
            <a:off x="5890214" y="1033889"/>
            <a:ext cx="865943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rs118038680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D63A8C1D-1401-8D48-37F9-D8D5D085EE6A}"/>
              </a:ext>
            </a:extLst>
          </p:cNvPr>
          <p:cNvSpPr txBox="1"/>
          <p:nvPr/>
        </p:nvSpPr>
        <p:spPr>
          <a:xfrm>
            <a:off x="8306610" y="1052180"/>
            <a:ext cx="801823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rs12499648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B016CB27-755C-D8B3-D8C9-130025DB3CE9}"/>
              </a:ext>
            </a:extLst>
          </p:cNvPr>
          <p:cNvSpPr txBox="1"/>
          <p:nvPr/>
        </p:nvSpPr>
        <p:spPr>
          <a:xfrm>
            <a:off x="10638431" y="1088397"/>
            <a:ext cx="865943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rs147403806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図 29">
            <a:extLst>
              <a:ext uri="{FF2B5EF4-FFF2-40B4-BE49-F238E27FC236}">
                <a16:creationId xmlns:a16="http://schemas.microsoft.com/office/drawing/2014/main" id="{51EFE6B9-41F1-4FE8-4D17-B743AE7B128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41760" y="2871835"/>
            <a:ext cx="2057140" cy="1440000"/>
          </a:xfrm>
          <a:prstGeom prst="rect">
            <a:avLst/>
          </a:prstGeom>
        </p:spPr>
      </p:pic>
      <p:pic>
        <p:nvPicPr>
          <p:cNvPr id="31" name="図 30">
            <a:extLst>
              <a:ext uri="{FF2B5EF4-FFF2-40B4-BE49-F238E27FC236}">
                <a16:creationId xmlns:a16="http://schemas.microsoft.com/office/drawing/2014/main" id="{0C7760CA-B498-C552-F8CC-A457981328C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918242" y="2871835"/>
            <a:ext cx="2057140" cy="1440000"/>
          </a:xfrm>
          <a:prstGeom prst="rect">
            <a:avLst/>
          </a:prstGeom>
        </p:spPr>
      </p:pic>
      <p:pic>
        <p:nvPicPr>
          <p:cNvPr id="32" name="図 31">
            <a:extLst>
              <a:ext uri="{FF2B5EF4-FFF2-40B4-BE49-F238E27FC236}">
                <a16:creationId xmlns:a16="http://schemas.microsoft.com/office/drawing/2014/main" id="{552B9F9E-39B0-85EB-2BCC-3C5AD0282F4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294724" y="2871835"/>
            <a:ext cx="2057144" cy="1440000"/>
          </a:xfrm>
          <a:prstGeom prst="rect">
            <a:avLst/>
          </a:prstGeom>
        </p:spPr>
      </p:pic>
      <p:pic>
        <p:nvPicPr>
          <p:cNvPr id="33" name="図 32">
            <a:extLst>
              <a:ext uri="{FF2B5EF4-FFF2-40B4-BE49-F238E27FC236}">
                <a16:creationId xmlns:a16="http://schemas.microsoft.com/office/drawing/2014/main" id="{0BEB7707-33E0-1C13-9AAA-45DAB6B6012B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671201" y="2871835"/>
            <a:ext cx="2057144" cy="1440000"/>
          </a:xfrm>
          <a:prstGeom prst="rect">
            <a:avLst/>
          </a:prstGeom>
        </p:spPr>
      </p:pic>
      <p:pic>
        <p:nvPicPr>
          <p:cNvPr id="34" name="図 33">
            <a:extLst>
              <a:ext uri="{FF2B5EF4-FFF2-40B4-BE49-F238E27FC236}">
                <a16:creationId xmlns:a16="http://schemas.microsoft.com/office/drawing/2014/main" id="{7BD69413-9A59-601C-8023-9FB527AA8A16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0047689" y="2871835"/>
            <a:ext cx="2057144" cy="1440000"/>
          </a:xfrm>
          <a:prstGeom prst="rect">
            <a:avLst/>
          </a:prstGeom>
        </p:spPr>
      </p:pic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3DC1781A-EE31-B103-80D8-E3E038B126E4}"/>
              </a:ext>
            </a:extLst>
          </p:cNvPr>
          <p:cNvSpPr txBox="1"/>
          <p:nvPr/>
        </p:nvSpPr>
        <p:spPr>
          <a:xfrm rot="16200000">
            <a:off x="218544" y="3415897"/>
            <a:ext cx="646432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AC76BFD9-AD01-2343-FA1E-116F470A6775}"/>
              </a:ext>
            </a:extLst>
          </p:cNvPr>
          <p:cNvSpPr txBox="1"/>
          <p:nvPr/>
        </p:nvSpPr>
        <p:spPr>
          <a:xfrm rot="16200000">
            <a:off x="2595024" y="3398917"/>
            <a:ext cx="646432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86F72DE9-5C31-4C66-6D28-54CC8667B970}"/>
              </a:ext>
            </a:extLst>
          </p:cNvPr>
          <p:cNvSpPr txBox="1"/>
          <p:nvPr/>
        </p:nvSpPr>
        <p:spPr>
          <a:xfrm rot="16200000">
            <a:off x="4971503" y="3373571"/>
            <a:ext cx="646432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0BD69652-2883-21CB-29F4-C6369BA1A96D}"/>
              </a:ext>
            </a:extLst>
          </p:cNvPr>
          <p:cNvSpPr txBox="1"/>
          <p:nvPr/>
        </p:nvSpPr>
        <p:spPr>
          <a:xfrm rot="16200000">
            <a:off x="7360275" y="3384436"/>
            <a:ext cx="646432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49EE5D18-5E37-82E1-4C20-15860E0A2C94}"/>
              </a:ext>
            </a:extLst>
          </p:cNvPr>
          <p:cNvSpPr txBox="1"/>
          <p:nvPr/>
        </p:nvSpPr>
        <p:spPr>
          <a:xfrm rot="16200000">
            <a:off x="9719001" y="3262226"/>
            <a:ext cx="646432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0C19A708-A35C-0703-EDFB-483B6602F411}"/>
              </a:ext>
            </a:extLst>
          </p:cNvPr>
          <p:cNvSpPr txBox="1"/>
          <p:nvPr/>
        </p:nvSpPr>
        <p:spPr>
          <a:xfrm>
            <a:off x="869375" y="4231086"/>
            <a:ext cx="1398140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osition on chr9 (Mb)</a:t>
            </a: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53E53DD5-835E-8EEF-8347-9AFED904DF4D}"/>
              </a:ext>
            </a:extLst>
          </p:cNvPr>
          <p:cNvSpPr txBox="1"/>
          <p:nvPr/>
        </p:nvSpPr>
        <p:spPr>
          <a:xfrm>
            <a:off x="3122847" y="4231086"/>
            <a:ext cx="154882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osition on chr9 (Mb)</a:t>
            </a: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BD3E8838-8E30-F1CC-0F5C-D778B706A04C}"/>
              </a:ext>
            </a:extLst>
          </p:cNvPr>
          <p:cNvSpPr txBox="1"/>
          <p:nvPr/>
        </p:nvSpPr>
        <p:spPr>
          <a:xfrm>
            <a:off x="5565473" y="4231086"/>
            <a:ext cx="1647073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osition on chr10 (Mb)</a:t>
            </a: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5BF6A837-8B0F-D5A4-CE6E-45FCF15949FF}"/>
              </a:ext>
            </a:extLst>
          </p:cNvPr>
          <p:cNvSpPr txBox="1"/>
          <p:nvPr/>
        </p:nvSpPr>
        <p:spPr>
          <a:xfrm>
            <a:off x="8064673" y="4231086"/>
            <a:ext cx="1468672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osition on chr15 (Mb)</a:t>
            </a: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76EFC5FA-179F-EE09-D2D0-EC6CB909D986}"/>
              </a:ext>
            </a:extLst>
          </p:cNvPr>
          <p:cNvSpPr txBox="1"/>
          <p:nvPr/>
        </p:nvSpPr>
        <p:spPr>
          <a:xfrm>
            <a:off x="10343794" y="4231086"/>
            <a:ext cx="1468672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osition on chr21 (Mb)</a:t>
            </a: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DB711D12-0562-0DB3-B1B7-F060641B4A79}"/>
              </a:ext>
            </a:extLst>
          </p:cNvPr>
          <p:cNvSpPr txBox="1"/>
          <p:nvPr/>
        </p:nvSpPr>
        <p:spPr>
          <a:xfrm>
            <a:off x="1204212" y="2987992"/>
            <a:ext cx="737702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rs7019089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5D371859-F67E-4EF1-0026-2DC21CF354EF}"/>
              </a:ext>
            </a:extLst>
          </p:cNvPr>
          <p:cNvSpPr txBox="1"/>
          <p:nvPr/>
        </p:nvSpPr>
        <p:spPr>
          <a:xfrm>
            <a:off x="3511633" y="2980369"/>
            <a:ext cx="865943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rs140769784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4CC3F0FF-99BC-7D51-D460-C06B902E3F6B}"/>
              </a:ext>
            </a:extLst>
          </p:cNvPr>
          <p:cNvSpPr txBox="1"/>
          <p:nvPr/>
        </p:nvSpPr>
        <p:spPr>
          <a:xfrm>
            <a:off x="5857975" y="2973578"/>
            <a:ext cx="801823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rs11595141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68C370FA-3E98-79BA-3F04-558F50F9C2A5}"/>
              </a:ext>
            </a:extLst>
          </p:cNvPr>
          <p:cNvSpPr txBox="1"/>
          <p:nvPr/>
        </p:nvSpPr>
        <p:spPr>
          <a:xfrm>
            <a:off x="8298778" y="3125007"/>
            <a:ext cx="801823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rs72732628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1C54909E-7DC8-2E4D-6616-F2C1075753EB}"/>
              </a:ext>
            </a:extLst>
          </p:cNvPr>
          <p:cNvSpPr txBox="1"/>
          <p:nvPr/>
        </p:nvSpPr>
        <p:spPr>
          <a:xfrm>
            <a:off x="10643986" y="2847413"/>
            <a:ext cx="865943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rs529360114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06F66964-CD8C-BE73-0012-123C74A72FC9}"/>
              </a:ext>
            </a:extLst>
          </p:cNvPr>
          <p:cNvSpPr txBox="1"/>
          <p:nvPr/>
        </p:nvSpPr>
        <p:spPr>
          <a:xfrm>
            <a:off x="5064115" y="2693772"/>
            <a:ext cx="2770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kumimoji="1" lang="ja-JP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D83FD93A-4C6F-A0D4-5FC8-DE009BDA8765}"/>
              </a:ext>
            </a:extLst>
          </p:cNvPr>
          <p:cNvSpPr txBox="1"/>
          <p:nvPr/>
        </p:nvSpPr>
        <p:spPr>
          <a:xfrm>
            <a:off x="2680572" y="2693772"/>
            <a:ext cx="2770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kumimoji="1" lang="ja-JP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BF07170C-BC97-DDD4-15BC-B9793781E908}"/>
              </a:ext>
            </a:extLst>
          </p:cNvPr>
          <p:cNvSpPr txBox="1"/>
          <p:nvPr/>
        </p:nvSpPr>
        <p:spPr>
          <a:xfrm>
            <a:off x="308518" y="2693772"/>
            <a:ext cx="2770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kumimoji="1" lang="ja-JP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184C82F7-2D24-5FA7-0D5B-A344C4FADE9E}"/>
              </a:ext>
            </a:extLst>
          </p:cNvPr>
          <p:cNvSpPr txBox="1"/>
          <p:nvPr/>
        </p:nvSpPr>
        <p:spPr>
          <a:xfrm>
            <a:off x="7441180" y="2693772"/>
            <a:ext cx="2770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kumimoji="1" lang="ja-JP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130AD2B9-9C2C-667D-17F2-2B7A95F017B1}"/>
              </a:ext>
            </a:extLst>
          </p:cNvPr>
          <p:cNvSpPr txBox="1"/>
          <p:nvPr/>
        </p:nvSpPr>
        <p:spPr>
          <a:xfrm>
            <a:off x="9813425" y="2693772"/>
            <a:ext cx="2770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endParaRPr kumimoji="1" lang="ja-JP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82D10739-4E57-EB73-AC0E-D5AA81B9A825}"/>
              </a:ext>
            </a:extLst>
          </p:cNvPr>
          <p:cNvSpPr txBox="1"/>
          <p:nvPr/>
        </p:nvSpPr>
        <p:spPr>
          <a:xfrm>
            <a:off x="358886" y="4821324"/>
            <a:ext cx="2770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endParaRPr kumimoji="1" lang="ja-JP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62719C09-695D-E263-2AB9-278B44CB8465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t="5244" b="-1874"/>
          <a:stretch/>
        </p:blipFill>
        <p:spPr>
          <a:xfrm>
            <a:off x="591009" y="4911884"/>
            <a:ext cx="2007891" cy="1440000"/>
          </a:xfrm>
          <a:prstGeom prst="rect">
            <a:avLst/>
          </a:prstGeom>
        </p:spPr>
      </p:pic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DA4A9CEC-BC4E-46EB-8C98-61F3B0506BE5}"/>
              </a:ext>
            </a:extLst>
          </p:cNvPr>
          <p:cNvSpPr txBox="1"/>
          <p:nvPr/>
        </p:nvSpPr>
        <p:spPr>
          <a:xfrm rot="16200000">
            <a:off x="152377" y="5418255"/>
            <a:ext cx="646432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正方形/長方形 55">
            <a:extLst>
              <a:ext uri="{FF2B5EF4-FFF2-40B4-BE49-F238E27FC236}">
                <a16:creationId xmlns:a16="http://schemas.microsoft.com/office/drawing/2014/main" id="{F3A1E541-D1F6-9C62-50B0-6D7CF34D6F5A}"/>
              </a:ext>
            </a:extLst>
          </p:cNvPr>
          <p:cNvSpPr/>
          <p:nvPr/>
        </p:nvSpPr>
        <p:spPr>
          <a:xfrm>
            <a:off x="1528214" y="5302963"/>
            <a:ext cx="424927" cy="13985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1A69171C-6281-FA23-02C9-F90F11C7E651}"/>
              </a:ext>
            </a:extLst>
          </p:cNvPr>
          <p:cNvSpPr txBox="1"/>
          <p:nvPr/>
        </p:nvSpPr>
        <p:spPr>
          <a:xfrm>
            <a:off x="1296353" y="5172905"/>
            <a:ext cx="813043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DAPK2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locus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CAC80876-8B60-DC32-B08C-D3362F399259}"/>
              </a:ext>
            </a:extLst>
          </p:cNvPr>
          <p:cNvSpPr txBox="1"/>
          <p:nvPr/>
        </p:nvSpPr>
        <p:spPr>
          <a:xfrm>
            <a:off x="935759" y="6247005"/>
            <a:ext cx="1542410" cy="25391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05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osition on chr15 (Mb)</a:t>
            </a: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C924CA7C-4FEF-A078-0D5F-181611EABED9}"/>
              </a:ext>
            </a:extLst>
          </p:cNvPr>
          <p:cNvSpPr txBox="1"/>
          <p:nvPr/>
        </p:nvSpPr>
        <p:spPr>
          <a:xfrm>
            <a:off x="3259366" y="5002692"/>
            <a:ext cx="878970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Lead variants: a) rs187486988, b) rs79794400, c) rs118038680, d) rs12499648, e) rs147403806, f) rs7019089, g) rs140769784, h) rs11595141, </a:t>
            </a:r>
            <a:r>
              <a:rPr lang="en-US" altLang="ja-JP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i</a:t>
            </a:r>
            <a:r>
              <a:rPr lang="en-US" altLang="ja-JP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) rs72732628 and j) rs529360114 in DG-GWAS.</a:t>
            </a:r>
          </a:p>
          <a:p>
            <a:r>
              <a:rPr lang="en-US" altLang="ja-JP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k)</a:t>
            </a:r>
            <a:r>
              <a:rPr lang="en-US" altLang="ja-JP" sz="1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8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Regional association plots for </a:t>
            </a:r>
            <a:r>
              <a:rPr lang="en-US" altLang="ja-JP" sz="1800" i="1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APK2</a:t>
            </a:r>
            <a:r>
              <a:rPr lang="ja-JP" altLang="en-US" i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in DG-GWAS</a:t>
            </a:r>
            <a:r>
              <a:rPr lang="en-US" altLang="ja-JP" sz="18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identified in TWAS</a:t>
            </a:r>
            <a:r>
              <a:rPr lang="en-US" altLang="ja-JP" sz="1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. </a:t>
            </a:r>
            <a:endParaRPr lang="ja-JP" altLang="ja-JP" sz="18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99600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EC4DACE-1824-A1BF-B14E-BEFA7DB76B68}"/>
              </a:ext>
            </a:extLst>
          </p:cNvPr>
          <p:cNvSpPr txBox="1"/>
          <p:nvPr/>
        </p:nvSpPr>
        <p:spPr>
          <a:xfrm>
            <a:off x="152876" y="38821"/>
            <a:ext cx="56092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Fig. S2. </a:t>
            </a:r>
            <a:r>
              <a:rPr lang="en-US" altLang="ja-JP" sz="18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Genetic correlations analysis</a:t>
            </a:r>
            <a:endParaRPr lang="ja-JP" altLang="ja-JP" sz="1800" kern="10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37DA1122-AA00-B584-043C-5D3FD9F0A25B}"/>
              </a:ext>
            </a:extLst>
          </p:cNvPr>
          <p:cNvSpPr txBox="1"/>
          <p:nvPr/>
        </p:nvSpPr>
        <p:spPr>
          <a:xfrm>
            <a:off x="118159" y="6172848"/>
            <a:ext cx="1195568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Each dot represents the genetic correlations with an error bar indicating the 95% confidence interval (CI). Asterisks indicate significant relationships (</a:t>
            </a:r>
            <a:r>
              <a:rPr lang="en-US" altLang="ja-JP" sz="18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</a:t>
            </a:r>
            <a:r>
              <a:rPr lang="en-US" altLang="ja-JP" sz="1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&lt; 0.05).</a:t>
            </a:r>
            <a:endParaRPr lang="ja-JP" altLang="ja-JP" sz="1800" kern="10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id="{4520E273-816F-6C89-DCC8-57D1B8BA68F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34554" y="408153"/>
            <a:ext cx="8255099" cy="57646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716315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EC4DACE-1824-A1BF-B14E-BEFA7DB76B68}"/>
              </a:ext>
            </a:extLst>
          </p:cNvPr>
          <p:cNvSpPr txBox="1"/>
          <p:nvPr/>
        </p:nvSpPr>
        <p:spPr>
          <a:xfrm>
            <a:off x="118159" y="38821"/>
            <a:ext cx="119556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Fig. S3. </a:t>
            </a:r>
            <a:r>
              <a:rPr lang="en-US" altLang="ja-JP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Regional association plots for conditional analysis in </a:t>
            </a:r>
            <a:r>
              <a:rPr lang="en-US" altLang="ja-JP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G</a:t>
            </a:r>
            <a:r>
              <a:rPr lang="en-US" altLang="ja-JP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-GWAS</a:t>
            </a:r>
            <a:endParaRPr lang="ja-JP" altLang="ja-JP" sz="1800" kern="10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id="{8F9BF462-8F09-531B-BCFB-84B96A8683A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72563" y="408153"/>
            <a:ext cx="2571429" cy="1800000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77B23E81-A224-EFF3-5628-E9C993FD7D7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69031" y="408153"/>
            <a:ext cx="2571429" cy="1800000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507E6E60-22FE-96BD-37C1-1AC7588BCEB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165498" y="408153"/>
            <a:ext cx="2571429" cy="1800000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5FA0DFAD-380C-4411-4960-0B6379A45D9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934518" y="2208153"/>
            <a:ext cx="2571429" cy="1800000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3964DA35-6F66-F9D5-8B03-5B982FCC031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825892" y="2208153"/>
            <a:ext cx="2571429" cy="1800000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CAF4F3FB-BF30-634E-25B9-2237870ACCE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717265" y="2208153"/>
            <a:ext cx="2571429" cy="1800000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800A1F25-F713-352E-7C1C-91D117CCAF4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825892" y="4115603"/>
            <a:ext cx="2571429" cy="1800000"/>
          </a:xfrm>
          <a:prstGeom prst="rect">
            <a:avLst/>
          </a:prstGeom>
        </p:spPr>
      </p:pic>
      <p:pic>
        <p:nvPicPr>
          <p:cNvPr id="18" name="図 17">
            <a:extLst>
              <a:ext uri="{FF2B5EF4-FFF2-40B4-BE49-F238E27FC236}">
                <a16:creationId xmlns:a16="http://schemas.microsoft.com/office/drawing/2014/main" id="{9289C57F-47CC-BB4D-E972-CC6F28A0EACA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717265" y="4115603"/>
            <a:ext cx="2571429" cy="1800000"/>
          </a:xfrm>
          <a:prstGeom prst="rect">
            <a:avLst/>
          </a:prstGeom>
        </p:spPr>
      </p:pic>
      <p:pic>
        <p:nvPicPr>
          <p:cNvPr id="19" name="図 18">
            <a:extLst>
              <a:ext uri="{FF2B5EF4-FFF2-40B4-BE49-F238E27FC236}">
                <a16:creationId xmlns:a16="http://schemas.microsoft.com/office/drawing/2014/main" id="{4620AD2A-51B9-F351-B096-A88033C51784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76095" y="408153"/>
            <a:ext cx="2571429" cy="1800000"/>
          </a:xfrm>
          <a:prstGeom prst="rect">
            <a:avLst/>
          </a:prstGeom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id="{BBBD38F1-57A3-975B-9A9A-7CC85019FE9C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934518" y="4115603"/>
            <a:ext cx="2571429" cy="1800000"/>
          </a:xfrm>
          <a:prstGeom prst="rect">
            <a:avLst/>
          </a:prstGeom>
        </p:spPr>
      </p:pic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350CCE17-B933-BABC-35C0-E86A5A83BC15}"/>
              </a:ext>
            </a:extLst>
          </p:cNvPr>
          <p:cNvSpPr txBox="1"/>
          <p:nvPr/>
        </p:nvSpPr>
        <p:spPr>
          <a:xfrm>
            <a:off x="316572" y="385411"/>
            <a:ext cx="2770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C8377CC8-09EE-5DC1-9CD2-3E8EC96C5359}"/>
              </a:ext>
            </a:extLst>
          </p:cNvPr>
          <p:cNvSpPr txBox="1"/>
          <p:nvPr/>
        </p:nvSpPr>
        <p:spPr>
          <a:xfrm>
            <a:off x="3227054" y="385411"/>
            <a:ext cx="2770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589942A2-4C76-E988-FD94-5B1F74D257E2}"/>
              </a:ext>
            </a:extLst>
          </p:cNvPr>
          <p:cNvSpPr txBox="1"/>
          <p:nvPr/>
        </p:nvSpPr>
        <p:spPr>
          <a:xfrm>
            <a:off x="6137536" y="385411"/>
            <a:ext cx="2770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8AB6A8F1-5480-2064-A09B-D17C4E416117}"/>
              </a:ext>
            </a:extLst>
          </p:cNvPr>
          <p:cNvSpPr txBox="1"/>
          <p:nvPr/>
        </p:nvSpPr>
        <p:spPr>
          <a:xfrm>
            <a:off x="9048018" y="385411"/>
            <a:ext cx="2770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A9F22F25-0773-5237-EB1E-1F84985FAFB0}"/>
              </a:ext>
            </a:extLst>
          </p:cNvPr>
          <p:cNvSpPr txBox="1"/>
          <p:nvPr/>
        </p:nvSpPr>
        <p:spPr>
          <a:xfrm>
            <a:off x="1783182" y="2208153"/>
            <a:ext cx="2770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23576CA1-FD86-13BE-8743-D6DEFF53AA4E}"/>
              </a:ext>
            </a:extLst>
          </p:cNvPr>
          <p:cNvSpPr txBox="1"/>
          <p:nvPr/>
        </p:nvSpPr>
        <p:spPr>
          <a:xfrm>
            <a:off x="1780069" y="4115603"/>
            <a:ext cx="2770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kumimoji="1" lang="ja-JP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8261D761-0884-097D-A3A9-504EDD677C11}"/>
              </a:ext>
            </a:extLst>
          </p:cNvPr>
          <p:cNvSpPr txBox="1"/>
          <p:nvPr/>
        </p:nvSpPr>
        <p:spPr>
          <a:xfrm>
            <a:off x="7554745" y="2208153"/>
            <a:ext cx="2770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kumimoji="1" lang="ja-JP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26D149C2-4AA9-00FF-56EC-EE42982005E2}"/>
              </a:ext>
            </a:extLst>
          </p:cNvPr>
          <p:cNvSpPr txBox="1"/>
          <p:nvPr/>
        </p:nvSpPr>
        <p:spPr>
          <a:xfrm>
            <a:off x="4668963" y="2208153"/>
            <a:ext cx="2770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kumimoji="1" lang="ja-JP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2A98527D-CB43-9C3B-7B40-1C496BE0BAC8}"/>
              </a:ext>
            </a:extLst>
          </p:cNvPr>
          <p:cNvSpPr txBox="1"/>
          <p:nvPr/>
        </p:nvSpPr>
        <p:spPr>
          <a:xfrm>
            <a:off x="4676053" y="4115603"/>
            <a:ext cx="2770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kumimoji="1" lang="ja-JP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78B03A90-B320-FAFA-1A76-703994870CD8}"/>
              </a:ext>
            </a:extLst>
          </p:cNvPr>
          <p:cNvSpPr txBox="1"/>
          <p:nvPr/>
        </p:nvSpPr>
        <p:spPr>
          <a:xfrm>
            <a:off x="7572037" y="4115603"/>
            <a:ext cx="2770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endParaRPr kumimoji="1" lang="ja-JP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4BE32096-EFED-7852-7A4F-37C0CB0A515A}"/>
              </a:ext>
            </a:extLst>
          </p:cNvPr>
          <p:cNvSpPr txBox="1"/>
          <p:nvPr/>
        </p:nvSpPr>
        <p:spPr>
          <a:xfrm>
            <a:off x="126181" y="6099997"/>
            <a:ext cx="1206581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Lead variants: a) </a:t>
            </a:r>
            <a:r>
              <a:rPr lang="en-US" altLang="ja-JP" sz="18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NBAS</a:t>
            </a:r>
            <a:r>
              <a:rPr lang="en-US" altLang="ja-JP" sz="1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b) </a:t>
            </a:r>
            <a:r>
              <a:rPr lang="en-US" altLang="ja-JP" i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LC9A9</a:t>
            </a:r>
            <a:r>
              <a:rPr lang="en-US" altLang="ja-JP" sz="1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c) </a:t>
            </a:r>
            <a:r>
              <a:rPr lang="en-US" altLang="ja-JP" i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ET2</a:t>
            </a:r>
            <a:r>
              <a:rPr lang="en-US" altLang="ja-JP" sz="1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d) </a:t>
            </a:r>
            <a:r>
              <a:rPr lang="en-US" altLang="ja-JP" i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YNPO2</a:t>
            </a:r>
            <a:r>
              <a:rPr lang="en-US" altLang="ja-JP" sz="1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e) </a:t>
            </a:r>
            <a:r>
              <a:rPr lang="en-US" altLang="ja-JP" i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ALN1</a:t>
            </a:r>
            <a:r>
              <a:rPr lang="en-US" altLang="ja-JP" sz="1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f) </a:t>
            </a:r>
            <a:r>
              <a:rPr lang="en-US" altLang="ja-JP" sz="18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GM5</a:t>
            </a:r>
            <a:r>
              <a:rPr lang="en-US" altLang="ja-JP" sz="1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g) </a:t>
            </a:r>
            <a:r>
              <a:rPr lang="en-US" altLang="ja-JP" i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LPPR1</a:t>
            </a:r>
            <a:r>
              <a:rPr lang="en-US" altLang="ja-JP" sz="1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h) </a:t>
            </a:r>
            <a:r>
              <a:rPr lang="en-US" altLang="ja-JP" sz="1800" i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VIL</a:t>
            </a:r>
            <a:r>
              <a:rPr lang="en-US" altLang="ja-JP" sz="18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</a:t>
            </a:r>
            <a:r>
              <a:rPr lang="en-US" altLang="ja-JP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i</a:t>
            </a:r>
            <a:r>
              <a:rPr lang="en-US" altLang="ja-JP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) </a:t>
            </a:r>
            <a:r>
              <a:rPr lang="en-US" altLang="ja-JP" i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WDR72</a:t>
            </a:r>
            <a:r>
              <a:rPr lang="en-US" altLang="ja-JP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and j) </a:t>
            </a:r>
            <a:r>
              <a:rPr lang="en-US" altLang="ja-JP" i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AM207A</a:t>
            </a:r>
            <a:r>
              <a:rPr lang="en-US" altLang="ja-JP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loci in conditional analysis for DG-GWAS. </a:t>
            </a:r>
            <a:endParaRPr lang="en-US" altLang="ja-JP" sz="18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050122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82</TotalTime>
  <Words>351</Words>
  <Application>Microsoft Office PowerPoint</Application>
  <PresentationFormat>ワイド画面</PresentationFormat>
  <Paragraphs>68</Paragraphs>
  <Slides>3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8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理紗 光森</dc:creator>
  <cp:lastModifiedBy>浩一 尾崎</cp:lastModifiedBy>
  <cp:revision>17</cp:revision>
  <dcterms:created xsi:type="dcterms:W3CDTF">2025-04-11T02:48:04Z</dcterms:created>
  <dcterms:modified xsi:type="dcterms:W3CDTF">2025-11-06T09:01:01Z</dcterms:modified>
</cp:coreProperties>
</file>